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0" r:id="rId3"/>
    <p:sldId id="261" r:id="rId4"/>
    <p:sldId id="256" r:id="rId5"/>
    <p:sldId id="257" r:id="rId6"/>
    <p:sldId id="258" r:id="rId7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5" autoAdjust="0"/>
    <p:restoredTop sz="94660"/>
  </p:normalViewPr>
  <p:slideViewPr>
    <p:cSldViewPr snapToGrid="0">
      <p:cViewPr>
        <p:scale>
          <a:sx n="147" d="100"/>
          <a:sy n="147" d="100"/>
        </p:scale>
        <p:origin x="1496" y="-2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obias Fehlmann" userId="S::tofe002@uni-saarland.de::4bcca3d1-de19-4401-a8f9-0b35f6b35757" providerId="AD" clId="Web-{893C94B9-331A-83B6-3A60-342CA60E2B79}"/>
    <pc:docChg chg="addSld modSld sldOrd">
      <pc:chgData name="Tobias Fehlmann" userId="S::tofe002@uni-saarland.de::4bcca3d1-de19-4401-a8f9-0b35f6b35757" providerId="AD" clId="Web-{893C94B9-331A-83B6-3A60-342CA60E2B79}" dt="2020-07-16T12:09:47.962" v="47" actId="1076"/>
      <pc:docMkLst>
        <pc:docMk/>
      </pc:docMkLst>
      <pc:sldChg chg="addSp modSp mod modShow">
        <pc:chgData name="Tobias Fehlmann" userId="S::tofe002@uni-saarland.de::4bcca3d1-de19-4401-a8f9-0b35f6b35757" providerId="AD" clId="Web-{893C94B9-331A-83B6-3A60-342CA60E2B79}" dt="2020-07-15T10:47:59.916" v="30" actId="20577"/>
        <pc:sldMkLst>
          <pc:docMk/>
          <pc:sldMk cId="702390904" sldId="259"/>
        </pc:sldMkLst>
        <pc:spChg chg="add mod">
          <ac:chgData name="Tobias Fehlmann" userId="S::tofe002@uni-saarland.de::4bcca3d1-de19-4401-a8f9-0b35f6b35757" providerId="AD" clId="Web-{893C94B9-331A-83B6-3A60-342CA60E2B79}" dt="2020-07-15T10:47:59.916" v="30" actId="20577"/>
          <ac:spMkLst>
            <pc:docMk/>
            <pc:sldMk cId="702390904" sldId="259"/>
            <ac:spMk id="2" creationId="{A0D8A35C-4D97-433A-9716-F6C1467891F5}"/>
          </ac:spMkLst>
        </pc:spChg>
      </pc:sldChg>
      <pc:sldChg chg="addSp delSp modSp new ord">
        <pc:chgData name="Tobias Fehlmann" userId="S::tofe002@uni-saarland.de::4bcca3d1-de19-4401-a8f9-0b35f6b35757" providerId="AD" clId="Web-{893C94B9-331A-83B6-3A60-342CA60E2B79}" dt="2020-07-16T12:09:30.931" v="45"/>
        <pc:sldMkLst>
          <pc:docMk/>
          <pc:sldMk cId="522985613" sldId="260"/>
        </pc:sldMkLst>
        <pc:spChg chg="del">
          <ac:chgData name="Tobias Fehlmann" userId="S::tofe002@uni-saarland.de::4bcca3d1-de19-4401-a8f9-0b35f6b35757" providerId="AD" clId="Web-{893C94B9-331A-83B6-3A60-342CA60E2B79}" dt="2020-07-15T15:48:12.278" v="35"/>
          <ac:spMkLst>
            <pc:docMk/>
            <pc:sldMk cId="522985613" sldId="260"/>
            <ac:spMk id="2" creationId="{524C683E-2B8D-4955-8A8A-6E80EC9D3338}"/>
          </ac:spMkLst>
        </pc:spChg>
        <pc:spChg chg="del">
          <ac:chgData name="Tobias Fehlmann" userId="S::tofe002@uni-saarland.de::4bcca3d1-de19-4401-a8f9-0b35f6b35757" providerId="AD" clId="Web-{893C94B9-331A-83B6-3A60-342CA60E2B79}" dt="2020-07-15T15:48:14.294" v="36"/>
          <ac:spMkLst>
            <pc:docMk/>
            <pc:sldMk cId="522985613" sldId="260"/>
            <ac:spMk id="3" creationId="{DB5D7585-0937-4816-961E-FEA8E79009A9}"/>
          </ac:spMkLst>
        </pc:spChg>
        <pc:picChg chg="add del mod">
          <ac:chgData name="Tobias Fehlmann" userId="S::tofe002@uni-saarland.de::4bcca3d1-de19-4401-a8f9-0b35f6b35757" providerId="AD" clId="Web-{893C94B9-331A-83B6-3A60-342CA60E2B79}" dt="2020-07-16T12:09:30.931" v="45"/>
          <ac:picMkLst>
            <pc:docMk/>
            <pc:sldMk cId="522985613" sldId="260"/>
            <ac:picMk id="2" creationId="{94BDB838-7CE2-4985-B78D-5DB1A637C34F}"/>
          </ac:picMkLst>
        </pc:picChg>
        <pc:picChg chg="add mod">
          <ac:chgData name="Tobias Fehlmann" userId="S::tofe002@uni-saarland.de::4bcca3d1-de19-4401-a8f9-0b35f6b35757" providerId="AD" clId="Web-{893C94B9-331A-83B6-3A60-342CA60E2B79}" dt="2020-07-15T15:48:49.575" v="39" actId="14100"/>
          <ac:picMkLst>
            <pc:docMk/>
            <pc:sldMk cId="522985613" sldId="260"/>
            <ac:picMk id="4" creationId="{B18E5D44-F8F6-465D-B31B-2C7D237640BF}"/>
          </ac:picMkLst>
        </pc:picChg>
      </pc:sldChg>
      <pc:sldChg chg="addSp delSp modSp new">
        <pc:chgData name="Tobias Fehlmann" userId="S::tofe002@uni-saarland.de::4bcca3d1-de19-4401-a8f9-0b35f6b35757" providerId="AD" clId="Web-{893C94B9-331A-83B6-3A60-342CA60E2B79}" dt="2020-07-16T12:09:47.962" v="47" actId="1076"/>
        <pc:sldMkLst>
          <pc:docMk/>
          <pc:sldMk cId="2958003938" sldId="261"/>
        </pc:sldMkLst>
        <pc:spChg chg="del">
          <ac:chgData name="Tobias Fehlmann" userId="S::tofe002@uni-saarland.de::4bcca3d1-de19-4401-a8f9-0b35f6b35757" providerId="AD" clId="Web-{893C94B9-331A-83B6-3A60-342CA60E2B79}" dt="2020-07-16T12:09:27.774" v="44"/>
          <ac:spMkLst>
            <pc:docMk/>
            <pc:sldMk cId="2958003938" sldId="261"/>
            <ac:spMk id="2" creationId="{E32FE0AD-ACDE-4AD1-82AA-7CE3EBF5A75A}"/>
          </ac:spMkLst>
        </pc:spChg>
        <pc:spChg chg="del">
          <ac:chgData name="Tobias Fehlmann" userId="S::tofe002@uni-saarland.de::4bcca3d1-de19-4401-a8f9-0b35f6b35757" providerId="AD" clId="Web-{893C94B9-331A-83B6-3A60-342CA60E2B79}" dt="2020-07-16T12:09:26.071" v="43"/>
          <ac:spMkLst>
            <pc:docMk/>
            <pc:sldMk cId="2958003938" sldId="261"/>
            <ac:spMk id="3" creationId="{0B6D379E-CC25-4077-A79E-E7A30A5417EE}"/>
          </ac:spMkLst>
        </pc:spChg>
        <pc:picChg chg="add mod">
          <ac:chgData name="Tobias Fehlmann" userId="S::tofe002@uni-saarland.de::4bcca3d1-de19-4401-a8f9-0b35f6b35757" providerId="AD" clId="Web-{893C94B9-331A-83B6-3A60-342CA60E2B79}" dt="2020-07-16T12:09:47.962" v="47" actId="1076"/>
          <ac:picMkLst>
            <pc:docMk/>
            <pc:sldMk cId="2958003938" sldId="261"/>
            <ac:picMk id="4" creationId="{62F82D40-75CE-4D9D-9D10-4708CAA5093B}"/>
          </ac:picMkLst>
        </pc:picChg>
      </pc:sldChg>
    </pc:docChg>
  </pc:docChgLst>
  <pc:docChgLst>
    <pc:chgData name="Tobias Fehlmann" userId="S::tofe002@uni-saarland.de::4bcca3d1-de19-4401-a8f9-0b35f6b35757" providerId="AD" clId="Web-{1317B8A5-A101-6A92-EF40-E8345A3FB0BA}"/>
    <pc:docChg chg="addSld modSld sldOrd">
      <pc:chgData name="Tobias Fehlmann" userId="S::tofe002@uni-saarland.de::4bcca3d1-de19-4401-a8f9-0b35f6b35757" providerId="AD" clId="Web-{1317B8A5-A101-6A92-EF40-E8345A3FB0BA}" dt="2020-07-20T03:15:55.068" v="46" actId="14100"/>
      <pc:docMkLst>
        <pc:docMk/>
      </pc:docMkLst>
      <pc:sldChg chg="addSp delSp modSp">
        <pc:chgData name="Tobias Fehlmann" userId="S::tofe002@uni-saarland.de::4bcca3d1-de19-4401-a8f9-0b35f6b35757" providerId="AD" clId="Web-{1317B8A5-A101-6A92-EF40-E8345A3FB0BA}" dt="2020-07-20T01:35:28.835" v="37"/>
        <pc:sldMkLst>
          <pc:docMk/>
          <pc:sldMk cId="522985613" sldId="260"/>
        </pc:sldMkLst>
        <pc:spChg chg="add del mod">
          <ac:chgData name="Tobias Fehlmann" userId="S::tofe002@uni-saarland.de::4bcca3d1-de19-4401-a8f9-0b35f6b35757" providerId="AD" clId="Web-{1317B8A5-A101-6A92-EF40-E8345A3FB0BA}" dt="2020-07-20T01:35:28.835" v="37"/>
          <ac:spMkLst>
            <pc:docMk/>
            <pc:sldMk cId="522985613" sldId="260"/>
            <ac:spMk id="3" creationId="{E6117049-0BA0-4789-8DA4-CC842628A241}"/>
          </ac:spMkLst>
        </pc:spChg>
        <pc:picChg chg="add mod">
          <ac:chgData name="Tobias Fehlmann" userId="S::tofe002@uni-saarland.de::4bcca3d1-de19-4401-a8f9-0b35f6b35757" providerId="AD" clId="Web-{1317B8A5-A101-6A92-EF40-E8345A3FB0BA}" dt="2020-07-20T01:33:41.865" v="22" actId="14100"/>
          <ac:picMkLst>
            <pc:docMk/>
            <pc:sldMk cId="522985613" sldId="260"/>
            <ac:picMk id="2" creationId="{711B423D-747D-45CB-AEAF-FD460CCBD83B}"/>
          </ac:picMkLst>
        </pc:picChg>
        <pc:picChg chg="del">
          <ac:chgData name="Tobias Fehlmann" userId="S::tofe002@uni-saarland.de::4bcca3d1-de19-4401-a8f9-0b35f6b35757" providerId="AD" clId="Web-{1317B8A5-A101-6A92-EF40-E8345A3FB0BA}" dt="2020-07-20T01:33:21.459" v="19"/>
          <ac:picMkLst>
            <pc:docMk/>
            <pc:sldMk cId="522985613" sldId="260"/>
            <ac:picMk id="4" creationId="{B18E5D44-F8F6-465D-B31B-2C7D237640BF}"/>
          </ac:picMkLst>
        </pc:picChg>
      </pc:sldChg>
      <pc:sldChg chg="addSp delSp modSp new ord">
        <pc:chgData name="Tobias Fehlmann" userId="S::tofe002@uni-saarland.de::4bcca3d1-de19-4401-a8f9-0b35f6b35757" providerId="AD" clId="Web-{1317B8A5-A101-6A92-EF40-E8345A3FB0BA}" dt="2020-07-20T03:15:55.068" v="46" actId="14100"/>
        <pc:sldMkLst>
          <pc:docMk/>
          <pc:sldMk cId="605267594" sldId="262"/>
        </pc:sldMkLst>
        <pc:spChg chg="del">
          <ac:chgData name="Tobias Fehlmann" userId="S::tofe002@uni-saarland.de::4bcca3d1-de19-4401-a8f9-0b35f6b35757" providerId="AD" clId="Web-{1317B8A5-A101-6A92-EF40-E8345A3FB0BA}" dt="2020-07-20T01:14:19.514" v="2"/>
          <ac:spMkLst>
            <pc:docMk/>
            <pc:sldMk cId="605267594" sldId="262"/>
            <ac:spMk id="2" creationId="{2A164765-1C63-4AB6-8A4A-2FEDBAAB375B}"/>
          </ac:spMkLst>
        </pc:spChg>
        <pc:spChg chg="del">
          <ac:chgData name="Tobias Fehlmann" userId="S::tofe002@uni-saarland.de::4bcca3d1-de19-4401-a8f9-0b35f6b35757" providerId="AD" clId="Web-{1317B8A5-A101-6A92-EF40-E8345A3FB0BA}" dt="2020-07-20T01:14:21.467" v="3"/>
          <ac:spMkLst>
            <pc:docMk/>
            <pc:sldMk cId="605267594" sldId="262"/>
            <ac:spMk id="3" creationId="{8D16B315-A0D6-4F08-AF97-7FE070D13977}"/>
          </ac:spMkLst>
        </pc:spChg>
        <pc:picChg chg="add del mod">
          <ac:chgData name="Tobias Fehlmann" userId="S::tofe002@uni-saarland.de::4bcca3d1-de19-4401-a8f9-0b35f6b35757" providerId="AD" clId="Web-{1317B8A5-A101-6A92-EF40-E8345A3FB0BA}" dt="2020-07-20T03:15:37.772" v="43"/>
          <ac:picMkLst>
            <pc:docMk/>
            <pc:sldMk cId="605267594" sldId="262"/>
            <ac:picMk id="2" creationId="{B3A13D47-2673-466D-8CD0-036C093F7BD8}"/>
          </ac:picMkLst>
        </pc:picChg>
        <pc:picChg chg="add mod">
          <ac:chgData name="Tobias Fehlmann" userId="S::tofe002@uni-saarland.de::4bcca3d1-de19-4401-a8f9-0b35f6b35757" providerId="AD" clId="Web-{1317B8A5-A101-6A92-EF40-E8345A3FB0BA}" dt="2020-07-20T03:15:55.068" v="46" actId="14100"/>
          <ac:picMkLst>
            <pc:docMk/>
            <pc:sldMk cId="605267594" sldId="262"/>
            <ac:picMk id="3" creationId="{E6E05DF9-623A-4786-A950-D2975083C252}"/>
          </ac:picMkLst>
        </pc:picChg>
        <pc:picChg chg="add del mod">
          <ac:chgData name="Tobias Fehlmann" userId="S::tofe002@uni-saarland.de::4bcca3d1-de19-4401-a8f9-0b35f6b35757" providerId="AD" clId="Web-{1317B8A5-A101-6A92-EF40-E8345A3FB0BA}" dt="2020-07-20T01:20:33.834" v="14"/>
          <ac:picMkLst>
            <pc:docMk/>
            <pc:sldMk cId="605267594" sldId="262"/>
            <ac:picMk id="4" creationId="{C46B86BB-B65F-4D2F-89F7-391113D75097}"/>
          </ac:picMkLst>
        </pc:picChg>
        <pc:picChg chg="add del mod">
          <ac:chgData name="Tobias Fehlmann" userId="S::tofe002@uni-saarland.de::4bcca3d1-de19-4401-a8f9-0b35f6b35757" providerId="AD" clId="Web-{1317B8A5-A101-6A92-EF40-E8345A3FB0BA}" dt="2020-07-20T02:10:52.851" v="38"/>
          <ac:picMkLst>
            <pc:docMk/>
            <pc:sldMk cId="605267594" sldId="262"/>
            <ac:picMk id="5" creationId="{A69D161D-D59C-4C49-9A3E-5C2A49561F03}"/>
          </ac:picMkLst>
        </pc:picChg>
      </pc:sldChg>
    </pc:docChg>
  </pc:docChgLst>
  <pc:docChgLst>
    <pc:chgData name="Tobias Fehlmann" userId="S::tofe002@uni-saarland.de::4bcca3d1-de19-4401-a8f9-0b35f6b35757" providerId="AD" clId="Web-{6AA6EFB0-7245-4EEC-8A34-554AD0115A8C}"/>
    <pc:docChg chg="mod addSld modSld modMainMaster setSldSz">
      <pc:chgData name="Tobias Fehlmann" userId="S::tofe002@uni-saarland.de::4bcca3d1-de19-4401-a8f9-0b35f6b35757" providerId="AD" clId="Web-{6AA6EFB0-7245-4EEC-8A34-554AD0115A8C}" dt="2020-07-10T17:07:00.920" v="222" actId="1076"/>
      <pc:docMkLst>
        <pc:docMk/>
      </pc:docMkLst>
      <pc:sldChg chg="addSp delSp modSp">
        <pc:chgData name="Tobias Fehlmann" userId="S::tofe002@uni-saarland.de::4bcca3d1-de19-4401-a8f9-0b35f6b35757" providerId="AD" clId="Web-{6AA6EFB0-7245-4EEC-8A34-554AD0115A8C}" dt="2020-07-10T16:18:37.958" v="28" actId="14100"/>
        <pc:sldMkLst>
          <pc:docMk/>
          <pc:sldMk cId="1577499883" sldId="256"/>
        </pc:sldMkLst>
        <pc:spChg chg="del">
          <ac:chgData name="Tobias Fehlmann" userId="S::tofe002@uni-saarland.de::4bcca3d1-de19-4401-a8f9-0b35f6b35757" providerId="AD" clId="Web-{6AA6EFB0-7245-4EEC-8A34-554AD0115A8C}" dt="2020-07-10T15:50:51.890" v="0"/>
          <ac:spMkLst>
            <pc:docMk/>
            <pc:sldMk cId="1577499883" sldId="256"/>
            <ac:spMk id="2" creationId="{00000000-0000-0000-0000-000000000000}"/>
          </ac:spMkLst>
        </pc:spChg>
        <pc:spChg chg="del">
          <ac:chgData name="Tobias Fehlmann" userId="S::tofe002@uni-saarland.de::4bcca3d1-de19-4401-a8f9-0b35f6b35757" providerId="AD" clId="Web-{6AA6EFB0-7245-4EEC-8A34-554AD0115A8C}" dt="2020-07-10T15:50:53.796" v="1"/>
          <ac:spMkLst>
            <pc:docMk/>
            <pc:sldMk cId="1577499883" sldId="256"/>
            <ac:spMk id="3" creationId="{00000000-0000-0000-0000-000000000000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18:24.177" v="25" actId="1076"/>
          <ac:spMkLst>
            <pc:docMk/>
            <pc:sldMk cId="1577499883" sldId="256"/>
            <ac:spMk id="7" creationId="{19AF46BC-24B5-4027-BEAF-9F6C3B196349}"/>
          </ac:spMkLst>
        </pc:spChg>
        <pc:picChg chg="add mod">
          <ac:chgData name="Tobias Fehlmann" userId="S::tofe002@uni-saarland.de::4bcca3d1-de19-4401-a8f9-0b35f6b35757" providerId="AD" clId="Web-{6AA6EFB0-7245-4EEC-8A34-554AD0115A8C}" dt="2020-07-10T16:18:37.958" v="28" actId="14100"/>
          <ac:picMkLst>
            <pc:docMk/>
            <pc:sldMk cId="1577499883" sldId="256"/>
            <ac:picMk id="4" creationId="{59A8BAEB-519D-4497-8DCC-2C7E41564B23}"/>
          </ac:picMkLst>
        </pc:picChg>
        <pc:picChg chg="add mod">
          <ac:chgData name="Tobias Fehlmann" userId="S::tofe002@uni-saarland.de::4bcca3d1-de19-4401-a8f9-0b35f6b35757" providerId="AD" clId="Web-{6AA6EFB0-7245-4EEC-8A34-554AD0115A8C}" dt="2020-07-10T16:18:31.864" v="27" actId="14100"/>
          <ac:picMkLst>
            <pc:docMk/>
            <pc:sldMk cId="1577499883" sldId="256"/>
            <ac:picMk id="5" creationId="{1E7E6C0D-CCEE-4349-9029-22CBE708D2EB}"/>
          </ac:picMkLst>
        </pc:picChg>
        <pc:picChg chg="add mod">
          <ac:chgData name="Tobias Fehlmann" userId="S::tofe002@uni-saarland.de::4bcca3d1-de19-4401-a8f9-0b35f6b35757" providerId="AD" clId="Web-{6AA6EFB0-7245-4EEC-8A34-554AD0115A8C}" dt="2020-07-10T16:18:27.020" v="26" actId="1076"/>
          <ac:picMkLst>
            <pc:docMk/>
            <pc:sldMk cId="1577499883" sldId="256"/>
            <ac:picMk id="6" creationId="{BBFE84DC-F5B7-49C7-AA54-9B169827F513}"/>
          </ac:picMkLst>
        </pc:picChg>
      </pc:sldChg>
      <pc:sldChg chg="addSp delSp modSp new">
        <pc:chgData name="Tobias Fehlmann" userId="S::tofe002@uni-saarland.de::4bcca3d1-de19-4401-a8f9-0b35f6b35757" providerId="AD" clId="Web-{6AA6EFB0-7245-4EEC-8A34-554AD0115A8C}" dt="2020-07-10T16:31:18.162" v="34" actId="14100"/>
        <pc:sldMkLst>
          <pc:docMk/>
          <pc:sldMk cId="1578934569" sldId="257"/>
        </pc:sldMkLst>
        <pc:spChg chg="del">
          <ac:chgData name="Tobias Fehlmann" userId="S::tofe002@uni-saarland.de::4bcca3d1-de19-4401-a8f9-0b35f6b35757" providerId="AD" clId="Web-{6AA6EFB0-7245-4EEC-8A34-554AD0115A8C}" dt="2020-07-10T16:19:17.770" v="30"/>
          <ac:spMkLst>
            <pc:docMk/>
            <pc:sldMk cId="1578934569" sldId="257"/>
            <ac:spMk id="2" creationId="{C2A5D3E1-2297-421F-A379-FA5C11A35239}"/>
          </ac:spMkLst>
        </pc:spChg>
        <pc:spChg chg="del">
          <ac:chgData name="Tobias Fehlmann" userId="S::tofe002@uni-saarland.de::4bcca3d1-de19-4401-a8f9-0b35f6b35757" providerId="AD" clId="Web-{6AA6EFB0-7245-4EEC-8A34-554AD0115A8C}" dt="2020-07-10T16:19:20.880" v="31"/>
          <ac:spMkLst>
            <pc:docMk/>
            <pc:sldMk cId="1578934569" sldId="257"/>
            <ac:spMk id="3" creationId="{3224651C-9FC4-4921-9BE2-50DDDD596318}"/>
          </ac:spMkLst>
        </pc:spChg>
        <pc:picChg chg="add mod">
          <ac:chgData name="Tobias Fehlmann" userId="S::tofe002@uni-saarland.de::4bcca3d1-de19-4401-a8f9-0b35f6b35757" providerId="AD" clId="Web-{6AA6EFB0-7245-4EEC-8A34-554AD0115A8C}" dt="2020-07-10T16:31:18.162" v="34" actId="14100"/>
          <ac:picMkLst>
            <pc:docMk/>
            <pc:sldMk cId="1578934569" sldId="257"/>
            <ac:picMk id="4" creationId="{77440597-53F2-4525-A94C-CA6A1165EBF1}"/>
          </ac:picMkLst>
        </pc:picChg>
      </pc:sldChg>
      <pc:sldChg chg="addSp delSp modSp new">
        <pc:chgData name="Tobias Fehlmann" userId="S::tofe002@uni-saarland.de::4bcca3d1-de19-4401-a8f9-0b35f6b35757" providerId="AD" clId="Web-{6AA6EFB0-7245-4EEC-8A34-554AD0115A8C}" dt="2020-07-10T16:57:05.873" v="214" actId="1076"/>
        <pc:sldMkLst>
          <pc:docMk/>
          <pc:sldMk cId="3236311434" sldId="258"/>
        </pc:sldMkLst>
        <pc:spChg chg="del">
          <ac:chgData name="Tobias Fehlmann" userId="S::tofe002@uni-saarland.de::4bcca3d1-de19-4401-a8f9-0b35f6b35757" providerId="AD" clId="Web-{6AA6EFB0-7245-4EEC-8A34-554AD0115A8C}" dt="2020-07-10T16:31:27.615" v="36"/>
          <ac:spMkLst>
            <pc:docMk/>
            <pc:sldMk cId="3236311434" sldId="258"/>
            <ac:spMk id="2" creationId="{20DF8CD7-024B-4131-A066-E70A64B5EE65}"/>
          </ac:spMkLst>
        </pc:spChg>
        <pc:spChg chg="del">
          <ac:chgData name="Tobias Fehlmann" userId="S::tofe002@uni-saarland.de::4bcca3d1-de19-4401-a8f9-0b35f6b35757" providerId="AD" clId="Web-{6AA6EFB0-7245-4EEC-8A34-554AD0115A8C}" dt="2020-07-10T16:31:30.099" v="37"/>
          <ac:spMkLst>
            <pc:docMk/>
            <pc:sldMk cId="3236311434" sldId="258"/>
            <ac:spMk id="3" creationId="{595C2C97-6ABD-4981-B825-7CE32B772CA6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7:05.873" v="214" actId="1076"/>
          <ac:spMkLst>
            <pc:docMk/>
            <pc:sldMk cId="3236311434" sldId="258"/>
            <ac:spMk id="9" creationId="{BBD786A5-571F-400C-BCCF-4F8B6EC749B0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6:24.092" v="210" actId="1076"/>
          <ac:spMkLst>
            <pc:docMk/>
            <pc:sldMk cId="3236311434" sldId="258"/>
            <ac:spMk id="10" creationId="{2EEF2B6C-BA4A-4662-9419-577933A90AC2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1:41.029" v="148" actId="1076"/>
          <ac:spMkLst>
            <pc:docMk/>
            <pc:sldMk cId="3236311434" sldId="258"/>
            <ac:spMk id="11" creationId="{776C0142-85D0-4E7F-BA5B-98553BFD9FE2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1:41.029" v="149" actId="1076"/>
          <ac:spMkLst>
            <pc:docMk/>
            <pc:sldMk cId="3236311434" sldId="258"/>
            <ac:spMk id="12" creationId="{142734F2-8ED6-4D2C-BAA8-E44FD57CDF5D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2:32.201" v="162" actId="1076"/>
          <ac:spMkLst>
            <pc:docMk/>
            <pc:sldMk cId="3236311434" sldId="258"/>
            <ac:spMk id="13" creationId="{AFE86D2E-B703-4D32-8048-7B9F53D4A17C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3:02.076" v="174" actId="1076"/>
          <ac:spMkLst>
            <pc:docMk/>
            <pc:sldMk cId="3236311434" sldId="258"/>
            <ac:spMk id="14" creationId="{CF8BB873-5E9B-4B8D-B9ED-2062C76DA252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3:48.357" v="186" actId="1076"/>
          <ac:spMkLst>
            <pc:docMk/>
            <pc:sldMk cId="3236311434" sldId="258"/>
            <ac:spMk id="15" creationId="{42D68AF1-F188-45E1-8EAA-11E35B676537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4:15.232" v="198" actId="1076"/>
          <ac:spMkLst>
            <pc:docMk/>
            <pc:sldMk cId="3236311434" sldId="258"/>
            <ac:spMk id="16" creationId="{BC49AB90-1E01-4192-8C7D-A7EB7707E3C3}"/>
          </ac:spMkLst>
        </pc:spChg>
        <pc:spChg chg="add mod">
          <ac:chgData name="Tobias Fehlmann" userId="S::tofe002@uni-saarland.de::4bcca3d1-de19-4401-a8f9-0b35f6b35757" providerId="AD" clId="Web-{6AA6EFB0-7245-4EEC-8A34-554AD0115A8C}" dt="2020-07-10T16:54:50.201" v="209" actId="1076"/>
          <ac:spMkLst>
            <pc:docMk/>
            <pc:sldMk cId="3236311434" sldId="258"/>
            <ac:spMk id="17" creationId="{51E543CC-083E-4E07-BDC5-E2E3992E0490}"/>
          </ac:spMkLst>
        </pc:spChg>
        <pc:picChg chg="add mod">
          <ac:chgData name="Tobias Fehlmann" userId="S::tofe002@uni-saarland.de::4bcca3d1-de19-4401-a8f9-0b35f6b35757" providerId="AD" clId="Web-{6AA6EFB0-7245-4EEC-8A34-554AD0115A8C}" dt="2020-07-10T16:38:49.694" v="41" actId="14100"/>
          <ac:picMkLst>
            <pc:docMk/>
            <pc:sldMk cId="3236311434" sldId="258"/>
            <ac:picMk id="4" creationId="{00ECBD10-DAD4-4EFA-84F4-F7668BE83DE2}"/>
          </ac:picMkLst>
        </pc:picChg>
        <pc:picChg chg="add mod">
          <ac:chgData name="Tobias Fehlmann" userId="S::tofe002@uni-saarland.de::4bcca3d1-de19-4401-a8f9-0b35f6b35757" providerId="AD" clId="Web-{6AA6EFB0-7245-4EEC-8A34-554AD0115A8C}" dt="2020-07-10T16:46:45.325" v="56" actId="14100"/>
          <ac:picMkLst>
            <pc:docMk/>
            <pc:sldMk cId="3236311434" sldId="258"/>
            <ac:picMk id="5" creationId="{CE968539-854D-436D-8752-F690C8FC8B52}"/>
          </ac:picMkLst>
        </pc:picChg>
        <pc:picChg chg="add mod">
          <ac:chgData name="Tobias Fehlmann" userId="S::tofe002@uni-saarland.de::4bcca3d1-de19-4401-a8f9-0b35f6b35757" providerId="AD" clId="Web-{6AA6EFB0-7245-4EEC-8A34-554AD0115A8C}" dt="2020-07-10T16:50:02.013" v="105" actId="1076"/>
          <ac:picMkLst>
            <pc:docMk/>
            <pc:sldMk cId="3236311434" sldId="258"/>
            <ac:picMk id="6" creationId="{06991170-43EC-4D06-9711-BE764CE94A7B}"/>
          </ac:picMkLst>
        </pc:picChg>
        <pc:picChg chg="add mod">
          <ac:chgData name="Tobias Fehlmann" userId="S::tofe002@uni-saarland.de::4bcca3d1-de19-4401-a8f9-0b35f6b35757" providerId="AD" clId="Web-{6AA6EFB0-7245-4EEC-8A34-554AD0115A8C}" dt="2020-07-10T16:47:15.935" v="59" actId="14100"/>
          <ac:picMkLst>
            <pc:docMk/>
            <pc:sldMk cId="3236311434" sldId="258"/>
            <ac:picMk id="7" creationId="{CE1E6D7D-4150-4D30-99C1-4051E97D2D07}"/>
          </ac:picMkLst>
        </pc:picChg>
        <pc:picChg chg="add mod">
          <ac:chgData name="Tobias Fehlmann" userId="S::tofe002@uni-saarland.de::4bcca3d1-de19-4401-a8f9-0b35f6b35757" providerId="AD" clId="Web-{6AA6EFB0-7245-4EEC-8A34-554AD0115A8C}" dt="2020-07-10T16:50:02.060" v="106" actId="1076"/>
          <ac:picMkLst>
            <pc:docMk/>
            <pc:sldMk cId="3236311434" sldId="258"/>
            <ac:picMk id="8" creationId="{8629DAD4-AF49-4DB7-8200-55BA426FACD2}"/>
          </ac:picMkLst>
        </pc:picChg>
      </pc:sldChg>
      <pc:sldChg chg="addSp delSp modSp new">
        <pc:chgData name="Tobias Fehlmann" userId="S::tofe002@uni-saarland.de::4bcca3d1-de19-4401-a8f9-0b35f6b35757" providerId="AD" clId="Web-{6AA6EFB0-7245-4EEC-8A34-554AD0115A8C}" dt="2020-07-10T17:07:00.920" v="222" actId="1076"/>
        <pc:sldMkLst>
          <pc:docMk/>
          <pc:sldMk cId="702390904" sldId="259"/>
        </pc:sldMkLst>
        <pc:spChg chg="del">
          <ac:chgData name="Tobias Fehlmann" userId="S::tofe002@uni-saarland.de::4bcca3d1-de19-4401-a8f9-0b35f6b35757" providerId="AD" clId="Web-{6AA6EFB0-7245-4EEC-8A34-554AD0115A8C}" dt="2020-07-10T16:58:18.373" v="217"/>
          <ac:spMkLst>
            <pc:docMk/>
            <pc:sldMk cId="702390904" sldId="259"/>
            <ac:spMk id="2" creationId="{489C8C32-9111-4F07-859B-3554393631E7}"/>
          </ac:spMkLst>
        </pc:spChg>
        <pc:spChg chg="del">
          <ac:chgData name="Tobias Fehlmann" userId="S::tofe002@uni-saarland.de::4bcca3d1-de19-4401-a8f9-0b35f6b35757" providerId="AD" clId="Web-{6AA6EFB0-7245-4EEC-8A34-554AD0115A8C}" dt="2020-07-10T16:58:16.357" v="216"/>
          <ac:spMkLst>
            <pc:docMk/>
            <pc:sldMk cId="702390904" sldId="259"/>
            <ac:spMk id="3" creationId="{2AFA6B09-72B9-4AFA-9A7D-6AFD9E127A7D}"/>
          </ac:spMkLst>
        </pc:spChg>
        <pc:picChg chg="add mod">
          <ac:chgData name="Tobias Fehlmann" userId="S::tofe002@uni-saarland.de::4bcca3d1-de19-4401-a8f9-0b35f6b35757" providerId="AD" clId="Web-{6AA6EFB0-7245-4EEC-8A34-554AD0115A8C}" dt="2020-07-10T17:07:00.920" v="222" actId="1076"/>
          <ac:picMkLst>
            <pc:docMk/>
            <pc:sldMk cId="702390904" sldId="259"/>
            <ac:picMk id="4" creationId="{2A9FC20B-4CEE-4137-A8A7-EC6BC3C3A3ED}"/>
          </ac:picMkLst>
        </pc:picChg>
      </pc:sldChg>
      <pc:sldMasterChg chg="modSp modSldLayout">
        <pc:chgData name="Tobias Fehlmann" userId="S::tofe002@uni-saarland.de::4bcca3d1-de19-4401-a8f9-0b35f6b35757" providerId="AD" clId="Web-{6AA6EFB0-7245-4EEC-8A34-554AD0115A8C}" dt="2020-07-10T15:51:04.843" v="2"/>
        <pc:sldMasterMkLst>
          <pc:docMk/>
          <pc:sldMasterMk cId="594725491" sldId="2147483648"/>
        </pc:sldMasterMkLst>
        <pc:spChg chg="mod">
          <ac:chgData name="Tobias Fehlmann" userId="S::tofe002@uni-saarland.de::4bcca3d1-de19-4401-a8f9-0b35f6b35757" providerId="AD" clId="Web-{6AA6EFB0-7245-4EEC-8A34-554AD0115A8C}" dt="2020-07-10T15:51:04.843" v="2"/>
          <ac:spMkLst>
            <pc:docMk/>
            <pc:sldMasterMk cId="594725491" sldId="2147483648"/>
            <ac:spMk id="2" creationId="{00000000-0000-0000-0000-000000000000}"/>
          </ac:spMkLst>
        </pc:spChg>
        <pc:spChg chg="mod">
          <ac:chgData name="Tobias Fehlmann" userId="S::tofe002@uni-saarland.de::4bcca3d1-de19-4401-a8f9-0b35f6b35757" providerId="AD" clId="Web-{6AA6EFB0-7245-4EEC-8A34-554AD0115A8C}" dt="2020-07-10T15:51:04.843" v="2"/>
          <ac:spMkLst>
            <pc:docMk/>
            <pc:sldMasterMk cId="594725491" sldId="2147483648"/>
            <ac:spMk id="3" creationId="{00000000-0000-0000-0000-000000000000}"/>
          </ac:spMkLst>
        </pc:spChg>
        <pc:spChg chg="mod">
          <ac:chgData name="Tobias Fehlmann" userId="S::tofe002@uni-saarland.de::4bcca3d1-de19-4401-a8f9-0b35f6b35757" providerId="AD" clId="Web-{6AA6EFB0-7245-4EEC-8A34-554AD0115A8C}" dt="2020-07-10T15:51:04.843" v="2"/>
          <ac:spMkLst>
            <pc:docMk/>
            <pc:sldMasterMk cId="594725491" sldId="2147483648"/>
            <ac:spMk id="4" creationId="{00000000-0000-0000-0000-000000000000}"/>
          </ac:spMkLst>
        </pc:spChg>
        <pc:spChg chg="mod">
          <ac:chgData name="Tobias Fehlmann" userId="S::tofe002@uni-saarland.de::4bcca3d1-de19-4401-a8f9-0b35f6b35757" providerId="AD" clId="Web-{6AA6EFB0-7245-4EEC-8A34-554AD0115A8C}" dt="2020-07-10T15:51:04.843" v="2"/>
          <ac:spMkLst>
            <pc:docMk/>
            <pc:sldMasterMk cId="594725491" sldId="2147483648"/>
            <ac:spMk id="5" creationId="{00000000-0000-0000-0000-000000000000}"/>
          </ac:spMkLst>
        </pc:spChg>
        <pc:spChg chg="mod">
          <ac:chgData name="Tobias Fehlmann" userId="S::tofe002@uni-saarland.de::4bcca3d1-de19-4401-a8f9-0b35f6b35757" providerId="AD" clId="Web-{6AA6EFB0-7245-4EEC-8A34-554AD0115A8C}" dt="2020-07-10T15:51:04.843" v="2"/>
          <ac:spMkLst>
            <pc:docMk/>
            <pc:sldMasterMk cId="594725491" sldId="2147483648"/>
            <ac:spMk id="6" creationId="{00000000-0000-0000-0000-000000000000}"/>
          </ac:spMkLst>
        </pc:spChg>
        <pc:sldLayoutChg chg="modSp">
          <pc:chgData name="Tobias Fehlmann" userId="S::tofe002@uni-saarland.de::4bcca3d1-de19-4401-a8f9-0b35f6b35757" providerId="AD" clId="Web-{6AA6EFB0-7245-4EEC-8A34-554AD0115A8C}" dt="2020-07-10T15:51:04.843" v="2"/>
          <pc:sldLayoutMkLst>
            <pc:docMk/>
            <pc:sldMasterMk cId="594725491" sldId="2147483648"/>
            <pc:sldLayoutMk cId="4043166929" sldId="2147483649"/>
          </pc:sldLayoutMkLst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4043166929" sldId="2147483649"/>
              <ac:spMk id="2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4043166929" sldId="2147483649"/>
              <ac:spMk id="3" creationId="{00000000-0000-0000-0000-000000000000}"/>
            </ac:spMkLst>
          </pc:spChg>
        </pc:sldLayoutChg>
        <pc:sldLayoutChg chg="modSp">
          <pc:chgData name="Tobias Fehlmann" userId="S::tofe002@uni-saarland.de::4bcca3d1-de19-4401-a8f9-0b35f6b35757" providerId="AD" clId="Web-{6AA6EFB0-7245-4EEC-8A34-554AD0115A8C}" dt="2020-07-10T15:51:04.843" v="2"/>
          <pc:sldLayoutMkLst>
            <pc:docMk/>
            <pc:sldMasterMk cId="594725491" sldId="2147483648"/>
            <pc:sldLayoutMk cId="2835585648" sldId="2147483651"/>
          </pc:sldLayoutMkLst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835585648" sldId="2147483651"/>
              <ac:spMk id="2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835585648" sldId="2147483651"/>
              <ac:spMk id="3" creationId="{00000000-0000-0000-0000-000000000000}"/>
            </ac:spMkLst>
          </pc:spChg>
        </pc:sldLayoutChg>
        <pc:sldLayoutChg chg="modSp">
          <pc:chgData name="Tobias Fehlmann" userId="S::tofe002@uni-saarland.de::4bcca3d1-de19-4401-a8f9-0b35f6b35757" providerId="AD" clId="Web-{6AA6EFB0-7245-4EEC-8A34-554AD0115A8C}" dt="2020-07-10T15:51:04.843" v="2"/>
          <pc:sldLayoutMkLst>
            <pc:docMk/>
            <pc:sldMasterMk cId="594725491" sldId="2147483648"/>
            <pc:sldLayoutMk cId="742901757" sldId="2147483652"/>
          </pc:sldLayoutMkLst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742901757" sldId="2147483652"/>
              <ac:spMk id="3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742901757" sldId="2147483652"/>
              <ac:spMk id="4" creationId="{00000000-0000-0000-0000-000000000000}"/>
            </ac:spMkLst>
          </pc:spChg>
        </pc:sldLayoutChg>
        <pc:sldLayoutChg chg="modSp">
          <pc:chgData name="Tobias Fehlmann" userId="S::tofe002@uni-saarland.de::4bcca3d1-de19-4401-a8f9-0b35f6b35757" providerId="AD" clId="Web-{6AA6EFB0-7245-4EEC-8A34-554AD0115A8C}" dt="2020-07-10T15:51:04.843" v="2"/>
          <pc:sldLayoutMkLst>
            <pc:docMk/>
            <pc:sldMasterMk cId="594725491" sldId="2147483648"/>
            <pc:sldLayoutMk cId="2024084034" sldId="2147483653"/>
          </pc:sldLayoutMkLst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024084034" sldId="2147483653"/>
              <ac:spMk id="2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024084034" sldId="2147483653"/>
              <ac:spMk id="3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024084034" sldId="2147483653"/>
              <ac:spMk id="4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024084034" sldId="2147483653"/>
              <ac:spMk id="5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024084034" sldId="2147483653"/>
              <ac:spMk id="6" creationId="{00000000-0000-0000-0000-000000000000}"/>
            </ac:spMkLst>
          </pc:spChg>
        </pc:sldLayoutChg>
        <pc:sldLayoutChg chg="modSp">
          <pc:chgData name="Tobias Fehlmann" userId="S::tofe002@uni-saarland.de::4bcca3d1-de19-4401-a8f9-0b35f6b35757" providerId="AD" clId="Web-{6AA6EFB0-7245-4EEC-8A34-554AD0115A8C}" dt="2020-07-10T15:51:04.843" v="2"/>
          <pc:sldLayoutMkLst>
            <pc:docMk/>
            <pc:sldMasterMk cId="594725491" sldId="2147483648"/>
            <pc:sldLayoutMk cId="3453883237" sldId="2147483656"/>
          </pc:sldLayoutMkLst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3453883237" sldId="2147483656"/>
              <ac:spMk id="2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3453883237" sldId="2147483656"/>
              <ac:spMk id="3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3453883237" sldId="2147483656"/>
              <ac:spMk id="4" creationId="{00000000-0000-0000-0000-000000000000}"/>
            </ac:spMkLst>
          </pc:spChg>
        </pc:sldLayoutChg>
        <pc:sldLayoutChg chg="modSp">
          <pc:chgData name="Tobias Fehlmann" userId="S::tofe002@uni-saarland.de::4bcca3d1-de19-4401-a8f9-0b35f6b35757" providerId="AD" clId="Web-{6AA6EFB0-7245-4EEC-8A34-554AD0115A8C}" dt="2020-07-10T15:51:04.843" v="2"/>
          <pc:sldLayoutMkLst>
            <pc:docMk/>
            <pc:sldMasterMk cId="594725491" sldId="2147483648"/>
            <pc:sldLayoutMk cId="2509888776" sldId="2147483657"/>
          </pc:sldLayoutMkLst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509888776" sldId="2147483657"/>
              <ac:spMk id="2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509888776" sldId="2147483657"/>
              <ac:spMk id="3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509888776" sldId="2147483657"/>
              <ac:spMk id="4" creationId="{00000000-0000-0000-0000-000000000000}"/>
            </ac:spMkLst>
          </pc:spChg>
        </pc:sldLayoutChg>
        <pc:sldLayoutChg chg="modSp">
          <pc:chgData name="Tobias Fehlmann" userId="S::tofe002@uni-saarland.de::4bcca3d1-de19-4401-a8f9-0b35f6b35757" providerId="AD" clId="Web-{6AA6EFB0-7245-4EEC-8A34-554AD0115A8C}" dt="2020-07-10T15:51:04.843" v="2"/>
          <pc:sldLayoutMkLst>
            <pc:docMk/>
            <pc:sldMasterMk cId="594725491" sldId="2147483648"/>
            <pc:sldLayoutMk cId="2809958959" sldId="2147483659"/>
          </pc:sldLayoutMkLst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809958959" sldId="2147483659"/>
              <ac:spMk id="2" creationId="{00000000-0000-0000-0000-000000000000}"/>
            </ac:spMkLst>
          </pc:spChg>
          <pc:spChg chg="mod">
            <ac:chgData name="Tobias Fehlmann" userId="S::tofe002@uni-saarland.de::4bcca3d1-de19-4401-a8f9-0b35f6b35757" providerId="AD" clId="Web-{6AA6EFB0-7245-4EEC-8A34-554AD0115A8C}" dt="2020-07-10T15:51:04.843" v="2"/>
            <ac:spMkLst>
              <pc:docMk/>
              <pc:sldMasterMk cId="594725491" sldId="2147483648"/>
              <pc:sldLayoutMk cId="2809958959" sldId="2147483659"/>
              <ac:spMk id="3" creationId="{00000000-0000-0000-0000-000000000000}"/>
            </ac:spMkLst>
          </pc:spChg>
        </pc:sldLayoutChg>
      </pc:sldMasterChg>
    </pc:docChg>
  </pc:docChgLst>
  <pc:docChgLst>
    <pc:chgData name="Tobias Fehlmann" userId="S::tofe002@uni-saarland.de::4bcca3d1-de19-4401-a8f9-0b35f6b35757" providerId="AD" clId="Web-{15E7B7CF-CB9B-9979-6135-29D4934118D0}"/>
    <pc:docChg chg="modSld">
      <pc:chgData name="Tobias Fehlmann" userId="S::tofe002@uni-saarland.de::4bcca3d1-de19-4401-a8f9-0b35f6b35757" providerId="AD" clId="Web-{15E7B7CF-CB9B-9979-6135-29D4934118D0}" dt="2020-07-21T11:22:59.677" v="12" actId="14100"/>
      <pc:docMkLst>
        <pc:docMk/>
      </pc:docMkLst>
      <pc:sldChg chg="addSp delSp modSp">
        <pc:chgData name="Tobias Fehlmann" userId="S::tofe002@uni-saarland.de::4bcca3d1-de19-4401-a8f9-0b35f6b35757" providerId="AD" clId="Web-{15E7B7CF-CB9B-9979-6135-29D4934118D0}" dt="2020-07-21T11:22:59.677" v="12" actId="14100"/>
        <pc:sldMkLst>
          <pc:docMk/>
          <pc:sldMk cId="522985613" sldId="260"/>
        </pc:sldMkLst>
        <pc:picChg chg="del">
          <ac:chgData name="Tobias Fehlmann" userId="S::tofe002@uni-saarland.de::4bcca3d1-de19-4401-a8f9-0b35f6b35757" providerId="AD" clId="Web-{15E7B7CF-CB9B-9979-6135-29D4934118D0}" dt="2020-07-21T11:18:30.081" v="0"/>
          <ac:picMkLst>
            <pc:docMk/>
            <pc:sldMk cId="522985613" sldId="260"/>
            <ac:picMk id="2" creationId="{711B423D-747D-45CB-AEAF-FD460CCBD83B}"/>
          </ac:picMkLst>
        </pc:picChg>
        <pc:picChg chg="add del mod">
          <ac:chgData name="Tobias Fehlmann" userId="S::tofe002@uni-saarland.de::4bcca3d1-de19-4401-a8f9-0b35f6b35757" providerId="AD" clId="Web-{15E7B7CF-CB9B-9979-6135-29D4934118D0}" dt="2020-07-21T11:20:22.676" v="4"/>
          <ac:picMkLst>
            <pc:docMk/>
            <pc:sldMk cId="522985613" sldId="260"/>
            <ac:picMk id="3" creationId="{B91698B8-B50A-4CFF-A1CE-5D3800710941}"/>
          </ac:picMkLst>
        </pc:picChg>
        <pc:picChg chg="add del mod">
          <ac:chgData name="Tobias Fehlmann" userId="S::tofe002@uni-saarland.de::4bcca3d1-de19-4401-a8f9-0b35f6b35757" providerId="AD" clId="Web-{15E7B7CF-CB9B-9979-6135-29D4934118D0}" dt="2020-07-21T11:22:41.223" v="8"/>
          <ac:picMkLst>
            <pc:docMk/>
            <pc:sldMk cId="522985613" sldId="260"/>
            <ac:picMk id="4" creationId="{9F66F3A2-E069-45ED-AD93-E4B0255AFFAC}"/>
          </ac:picMkLst>
        </pc:picChg>
        <pc:picChg chg="add mod">
          <ac:chgData name="Tobias Fehlmann" userId="S::tofe002@uni-saarland.de::4bcca3d1-de19-4401-a8f9-0b35f6b35757" providerId="AD" clId="Web-{15E7B7CF-CB9B-9979-6135-29D4934118D0}" dt="2020-07-21T11:22:59.677" v="12" actId="14100"/>
          <ac:picMkLst>
            <pc:docMk/>
            <pc:sldMk cId="522985613" sldId="260"/>
            <ac:picMk id="5" creationId="{4A6ACD74-14EB-4D49-9396-EEC766BE6B57}"/>
          </ac:picMkLst>
        </pc:picChg>
      </pc:sldChg>
    </pc:docChg>
  </pc:docChgLst>
  <pc:docChgLst>
    <pc:chgData name="Tobias Fehlmann" userId="S::tofe002@uni-saarland.de::4bcca3d1-de19-4401-a8f9-0b35f6b35757" providerId="AD" clId="Web-{B70E7169-8A18-5A25-7A73-6EB63D010669}"/>
    <pc:docChg chg="delSld modSld">
      <pc:chgData name="Tobias Fehlmann" userId="S::tofe002@uni-saarland.de::4bcca3d1-de19-4401-a8f9-0b35f6b35757" providerId="AD" clId="Web-{B70E7169-8A18-5A25-7A73-6EB63D010669}" dt="2020-08-04T15:09:00.839" v="98" actId="14100"/>
      <pc:docMkLst>
        <pc:docMk/>
      </pc:docMkLst>
      <pc:sldChg chg="addSp modSp">
        <pc:chgData name="Tobias Fehlmann" userId="S::tofe002@uni-saarland.de::4bcca3d1-de19-4401-a8f9-0b35f6b35757" providerId="AD" clId="Web-{B70E7169-8A18-5A25-7A73-6EB63D010669}" dt="2020-08-04T14:36:08.628" v="30" actId="1076"/>
        <pc:sldMkLst>
          <pc:docMk/>
          <pc:sldMk cId="1577499883" sldId="256"/>
        </pc:sldMkLst>
        <pc:spChg chg="add mod">
          <ac:chgData name="Tobias Fehlmann" userId="S::tofe002@uni-saarland.de::4bcca3d1-de19-4401-a8f9-0b35f6b35757" providerId="AD" clId="Web-{B70E7169-8A18-5A25-7A73-6EB63D010669}" dt="2020-08-04T14:35:59.722" v="24" actId="20577"/>
          <ac:spMkLst>
            <pc:docMk/>
            <pc:sldMk cId="1577499883" sldId="256"/>
            <ac:spMk id="2" creationId="{1433B60D-C21E-4738-A749-A270B53DE167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36:08.628" v="30" actId="1076"/>
          <ac:spMkLst>
            <pc:docMk/>
            <pc:sldMk cId="1577499883" sldId="256"/>
            <ac:spMk id="7" creationId="{19AF46BC-24B5-4027-BEAF-9F6C3B196349}"/>
          </ac:spMkLst>
        </pc:spChg>
        <pc:picChg chg="mod">
          <ac:chgData name="Tobias Fehlmann" userId="S::tofe002@uni-saarland.de::4bcca3d1-de19-4401-a8f9-0b35f6b35757" providerId="AD" clId="Web-{B70E7169-8A18-5A25-7A73-6EB63D010669}" dt="2020-08-04T14:36:08.253" v="27" actId="1076"/>
          <ac:picMkLst>
            <pc:docMk/>
            <pc:sldMk cId="1577499883" sldId="256"/>
            <ac:picMk id="4" creationId="{59A8BAEB-519D-4497-8DCC-2C7E41564B23}"/>
          </ac:picMkLst>
        </pc:picChg>
        <pc:picChg chg="mod">
          <ac:chgData name="Tobias Fehlmann" userId="S::tofe002@uni-saarland.de::4bcca3d1-de19-4401-a8f9-0b35f6b35757" providerId="AD" clId="Web-{B70E7169-8A18-5A25-7A73-6EB63D010669}" dt="2020-08-04T14:36:08.550" v="28" actId="1076"/>
          <ac:picMkLst>
            <pc:docMk/>
            <pc:sldMk cId="1577499883" sldId="256"/>
            <ac:picMk id="5" creationId="{1E7E6C0D-CCEE-4349-9029-22CBE708D2EB}"/>
          </ac:picMkLst>
        </pc:picChg>
        <pc:picChg chg="mod">
          <ac:chgData name="Tobias Fehlmann" userId="S::tofe002@uni-saarland.de::4bcca3d1-de19-4401-a8f9-0b35f6b35757" providerId="AD" clId="Web-{B70E7169-8A18-5A25-7A73-6EB63D010669}" dt="2020-08-04T14:36:08.628" v="29" actId="1076"/>
          <ac:picMkLst>
            <pc:docMk/>
            <pc:sldMk cId="1577499883" sldId="256"/>
            <ac:picMk id="6" creationId="{BBFE84DC-F5B7-49C7-AA54-9B169827F513}"/>
          </ac:picMkLst>
        </pc:picChg>
      </pc:sldChg>
      <pc:sldChg chg="addSp delSp modSp">
        <pc:chgData name="Tobias Fehlmann" userId="S::tofe002@uni-saarland.de::4bcca3d1-de19-4401-a8f9-0b35f6b35757" providerId="AD" clId="Web-{B70E7169-8A18-5A25-7A73-6EB63D010669}" dt="2020-08-04T14:35:51.144" v="20" actId="20577"/>
        <pc:sldMkLst>
          <pc:docMk/>
          <pc:sldMk cId="1578934569" sldId="257"/>
        </pc:sldMkLst>
        <pc:spChg chg="add mod">
          <ac:chgData name="Tobias Fehlmann" userId="S::tofe002@uni-saarland.de::4bcca3d1-de19-4401-a8f9-0b35f6b35757" providerId="AD" clId="Web-{B70E7169-8A18-5A25-7A73-6EB63D010669}" dt="2020-08-04T14:35:51.144" v="20" actId="20577"/>
          <ac:spMkLst>
            <pc:docMk/>
            <pc:sldMk cId="1578934569" sldId="257"/>
            <ac:spMk id="5" creationId="{13390F6F-6E6D-4971-BD39-7BA53E2CC75F}"/>
          </ac:spMkLst>
        </pc:spChg>
        <pc:picChg chg="add mod">
          <ac:chgData name="Tobias Fehlmann" userId="S::tofe002@uni-saarland.de::4bcca3d1-de19-4401-a8f9-0b35f6b35757" providerId="AD" clId="Web-{B70E7169-8A18-5A25-7A73-6EB63D010669}" dt="2020-08-04T14:34:44.190" v="4" actId="1076"/>
          <ac:picMkLst>
            <pc:docMk/>
            <pc:sldMk cId="1578934569" sldId="257"/>
            <ac:picMk id="2" creationId="{9992E18E-0A0A-487E-96A4-F8766E1944F4}"/>
          </ac:picMkLst>
        </pc:picChg>
        <pc:picChg chg="del">
          <ac:chgData name="Tobias Fehlmann" userId="S::tofe002@uni-saarland.de::4bcca3d1-de19-4401-a8f9-0b35f6b35757" providerId="AD" clId="Web-{B70E7169-8A18-5A25-7A73-6EB63D010669}" dt="2020-08-04T14:33:41.767" v="0"/>
          <ac:picMkLst>
            <pc:docMk/>
            <pc:sldMk cId="1578934569" sldId="257"/>
            <ac:picMk id="4" creationId="{77440597-53F2-4525-A94C-CA6A1165EBF1}"/>
          </ac:picMkLst>
        </pc:picChg>
      </pc:sldChg>
      <pc:sldChg chg="addSp modSp">
        <pc:chgData name="Tobias Fehlmann" userId="S::tofe002@uni-saarland.de::4bcca3d1-de19-4401-a8f9-0b35f6b35757" providerId="AD" clId="Web-{B70E7169-8A18-5A25-7A73-6EB63D010669}" dt="2020-08-04T14:41:30.179" v="93" actId="1076"/>
        <pc:sldMkLst>
          <pc:docMk/>
          <pc:sldMk cId="3236311434" sldId="258"/>
        </pc:sldMkLst>
        <pc:spChg chg="add mod">
          <ac:chgData name="Tobias Fehlmann" userId="S::tofe002@uni-saarland.de::4bcca3d1-de19-4401-a8f9-0b35f6b35757" providerId="AD" clId="Web-{B70E7169-8A18-5A25-7A73-6EB63D010669}" dt="2020-08-04T14:41:02.710" v="59" actId="20577"/>
          <ac:spMkLst>
            <pc:docMk/>
            <pc:sldMk cId="3236311434" sldId="258"/>
            <ac:spMk id="2" creationId="{62623E29-8183-4EB1-AB43-B92DB89C3EC6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32" v="85" actId="1076"/>
          <ac:spMkLst>
            <pc:docMk/>
            <pc:sldMk cId="3236311434" sldId="258"/>
            <ac:spMk id="9" creationId="{BBD786A5-571F-400C-BCCF-4F8B6EC749B0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32" v="86" actId="1076"/>
          <ac:spMkLst>
            <pc:docMk/>
            <pc:sldMk cId="3236311434" sldId="258"/>
            <ac:spMk id="10" creationId="{2EEF2B6C-BA4A-4662-9419-577933A90AC2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48" v="87" actId="1076"/>
          <ac:spMkLst>
            <pc:docMk/>
            <pc:sldMk cId="3236311434" sldId="258"/>
            <ac:spMk id="11" creationId="{776C0142-85D0-4E7F-BA5B-98553BFD9FE2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48" v="88" actId="1076"/>
          <ac:spMkLst>
            <pc:docMk/>
            <pc:sldMk cId="3236311434" sldId="258"/>
            <ac:spMk id="12" creationId="{142734F2-8ED6-4D2C-BAA8-E44FD57CDF5D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48" v="89" actId="1076"/>
          <ac:spMkLst>
            <pc:docMk/>
            <pc:sldMk cId="3236311434" sldId="258"/>
            <ac:spMk id="13" creationId="{AFE86D2E-B703-4D32-8048-7B9F53D4A17C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63" v="90" actId="1076"/>
          <ac:spMkLst>
            <pc:docMk/>
            <pc:sldMk cId="3236311434" sldId="258"/>
            <ac:spMk id="14" creationId="{CF8BB873-5E9B-4B8D-B9ED-2062C76DA252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63" v="91" actId="1076"/>
          <ac:spMkLst>
            <pc:docMk/>
            <pc:sldMk cId="3236311434" sldId="258"/>
            <ac:spMk id="15" creationId="{42D68AF1-F188-45E1-8EAA-11E35B676537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63" v="92" actId="1076"/>
          <ac:spMkLst>
            <pc:docMk/>
            <pc:sldMk cId="3236311434" sldId="258"/>
            <ac:spMk id="16" creationId="{BC49AB90-1E01-4192-8C7D-A7EB7707E3C3}"/>
          </ac:spMkLst>
        </pc:spChg>
        <pc:spChg chg="mod">
          <ac:chgData name="Tobias Fehlmann" userId="S::tofe002@uni-saarland.de::4bcca3d1-de19-4401-a8f9-0b35f6b35757" providerId="AD" clId="Web-{B70E7169-8A18-5A25-7A73-6EB63D010669}" dt="2020-08-04T14:41:30.179" v="93" actId="1076"/>
          <ac:spMkLst>
            <pc:docMk/>
            <pc:sldMk cId="3236311434" sldId="258"/>
            <ac:spMk id="17" creationId="{51E543CC-083E-4E07-BDC5-E2E3992E0490}"/>
          </ac:spMkLst>
        </pc:spChg>
        <pc:picChg chg="mod">
          <ac:chgData name="Tobias Fehlmann" userId="S::tofe002@uni-saarland.de::4bcca3d1-de19-4401-a8f9-0b35f6b35757" providerId="AD" clId="Web-{B70E7169-8A18-5A25-7A73-6EB63D010669}" dt="2020-08-04T14:41:30.007" v="80" actId="1076"/>
          <ac:picMkLst>
            <pc:docMk/>
            <pc:sldMk cId="3236311434" sldId="258"/>
            <ac:picMk id="4" creationId="{00ECBD10-DAD4-4EFA-84F4-F7668BE83DE2}"/>
          </ac:picMkLst>
        </pc:picChg>
        <pc:picChg chg="mod">
          <ac:chgData name="Tobias Fehlmann" userId="S::tofe002@uni-saarland.de::4bcca3d1-de19-4401-a8f9-0b35f6b35757" providerId="AD" clId="Web-{B70E7169-8A18-5A25-7A73-6EB63D010669}" dt="2020-08-04T14:41:30.023" v="81" actId="1076"/>
          <ac:picMkLst>
            <pc:docMk/>
            <pc:sldMk cId="3236311434" sldId="258"/>
            <ac:picMk id="5" creationId="{CE968539-854D-436D-8752-F690C8FC8B52}"/>
          </ac:picMkLst>
        </pc:picChg>
        <pc:picChg chg="mod">
          <ac:chgData name="Tobias Fehlmann" userId="S::tofe002@uni-saarland.de::4bcca3d1-de19-4401-a8f9-0b35f6b35757" providerId="AD" clId="Web-{B70E7169-8A18-5A25-7A73-6EB63D010669}" dt="2020-08-04T14:41:30.069" v="82" actId="1076"/>
          <ac:picMkLst>
            <pc:docMk/>
            <pc:sldMk cId="3236311434" sldId="258"/>
            <ac:picMk id="6" creationId="{06991170-43EC-4D06-9711-BE764CE94A7B}"/>
          </ac:picMkLst>
        </pc:picChg>
        <pc:picChg chg="mod">
          <ac:chgData name="Tobias Fehlmann" userId="S::tofe002@uni-saarland.de::4bcca3d1-de19-4401-a8f9-0b35f6b35757" providerId="AD" clId="Web-{B70E7169-8A18-5A25-7A73-6EB63D010669}" dt="2020-08-04T14:41:30.085" v="83" actId="1076"/>
          <ac:picMkLst>
            <pc:docMk/>
            <pc:sldMk cId="3236311434" sldId="258"/>
            <ac:picMk id="7" creationId="{CE1E6D7D-4150-4D30-99C1-4051E97D2D07}"/>
          </ac:picMkLst>
        </pc:picChg>
        <pc:picChg chg="mod">
          <ac:chgData name="Tobias Fehlmann" userId="S::tofe002@uni-saarland.de::4bcca3d1-de19-4401-a8f9-0b35f6b35757" providerId="AD" clId="Web-{B70E7169-8A18-5A25-7A73-6EB63D010669}" dt="2020-08-04T14:41:30.132" v="84" actId="1076"/>
          <ac:picMkLst>
            <pc:docMk/>
            <pc:sldMk cId="3236311434" sldId="258"/>
            <ac:picMk id="8" creationId="{8629DAD4-AF49-4DB7-8200-55BA426FACD2}"/>
          </ac:picMkLst>
        </pc:picChg>
      </pc:sldChg>
      <pc:sldChg chg="del">
        <pc:chgData name="Tobias Fehlmann" userId="S::tofe002@uni-saarland.de::4bcca3d1-de19-4401-a8f9-0b35f6b35757" providerId="AD" clId="Web-{B70E7169-8A18-5A25-7A73-6EB63D010669}" dt="2020-08-04T14:41:37.491" v="94"/>
        <pc:sldMkLst>
          <pc:docMk/>
          <pc:sldMk cId="702390904" sldId="259"/>
        </pc:sldMkLst>
      </pc:sldChg>
      <pc:sldChg chg="addSp delSp modSp">
        <pc:chgData name="Tobias Fehlmann" userId="S::tofe002@uni-saarland.de::4bcca3d1-de19-4401-a8f9-0b35f6b35757" providerId="AD" clId="Web-{B70E7169-8A18-5A25-7A73-6EB63D010669}" dt="2020-08-04T14:40:26.334" v="49" actId="1076"/>
        <pc:sldMkLst>
          <pc:docMk/>
          <pc:sldMk cId="522985613" sldId="260"/>
        </pc:sldMkLst>
        <pc:spChg chg="add del">
          <ac:chgData name="Tobias Fehlmann" userId="S::tofe002@uni-saarland.de::4bcca3d1-de19-4401-a8f9-0b35f6b35757" providerId="AD" clId="Web-{B70E7169-8A18-5A25-7A73-6EB63D010669}" dt="2020-08-04T14:37:22.176" v="40"/>
          <ac:spMkLst>
            <pc:docMk/>
            <pc:sldMk cId="522985613" sldId="260"/>
            <ac:spMk id="2" creationId="{11C2E009-A8E4-42DA-B34E-35A0AF68056E}"/>
          </ac:spMkLst>
        </pc:spChg>
        <pc:spChg chg="add mod">
          <ac:chgData name="Tobias Fehlmann" userId="S::tofe002@uni-saarland.de::4bcca3d1-de19-4401-a8f9-0b35f6b35757" providerId="AD" clId="Web-{B70E7169-8A18-5A25-7A73-6EB63D010669}" dt="2020-08-04T14:40:22.772" v="46" actId="20577"/>
          <ac:spMkLst>
            <pc:docMk/>
            <pc:sldMk cId="522985613" sldId="260"/>
            <ac:spMk id="4" creationId="{7A71BACE-4A49-4BCE-8223-A7A7A8C2347B}"/>
          </ac:spMkLst>
        </pc:spChg>
        <pc:picChg chg="add mod">
          <ac:chgData name="Tobias Fehlmann" userId="S::tofe002@uni-saarland.de::4bcca3d1-de19-4401-a8f9-0b35f6b35757" providerId="AD" clId="Web-{B70E7169-8A18-5A25-7A73-6EB63D010669}" dt="2020-08-04T14:40:26.334" v="49" actId="1076"/>
          <ac:picMkLst>
            <pc:docMk/>
            <pc:sldMk cId="522985613" sldId="260"/>
            <ac:picMk id="3" creationId="{BAF90315-7961-43ED-AD70-A4A7C6456D34}"/>
          </ac:picMkLst>
        </pc:picChg>
        <pc:picChg chg="del mod">
          <ac:chgData name="Tobias Fehlmann" userId="S::tofe002@uni-saarland.de::4bcca3d1-de19-4401-a8f9-0b35f6b35757" providerId="AD" clId="Web-{B70E7169-8A18-5A25-7A73-6EB63D010669}" dt="2020-08-04T14:39:37.834" v="41"/>
          <ac:picMkLst>
            <pc:docMk/>
            <pc:sldMk cId="522985613" sldId="260"/>
            <ac:picMk id="5" creationId="{4A6ACD74-14EB-4D49-9396-EEC766BE6B57}"/>
          </ac:picMkLst>
        </pc:picChg>
      </pc:sldChg>
      <pc:sldChg chg="addSp delSp modSp">
        <pc:chgData name="Tobias Fehlmann" userId="S::tofe002@uni-saarland.de::4bcca3d1-de19-4401-a8f9-0b35f6b35757" providerId="AD" clId="Web-{B70E7169-8A18-5A25-7A73-6EB63D010669}" dt="2020-08-04T14:40:30.225" v="50" actId="1076"/>
        <pc:sldMkLst>
          <pc:docMk/>
          <pc:sldMk cId="2958003938" sldId="261"/>
        </pc:sldMkLst>
        <pc:spChg chg="add del mod">
          <ac:chgData name="Tobias Fehlmann" userId="S::tofe002@uni-saarland.de::4bcca3d1-de19-4401-a8f9-0b35f6b35757" providerId="AD" clId="Web-{B70E7169-8A18-5A25-7A73-6EB63D010669}" dt="2020-08-04T14:36:27.300" v="35" actId="20577"/>
          <ac:spMkLst>
            <pc:docMk/>
            <pc:sldMk cId="2958003938" sldId="261"/>
            <ac:spMk id="4" creationId="{1632CA7C-2411-4FB1-876D-EA9693C76C2C}"/>
          </ac:spMkLst>
        </pc:spChg>
        <pc:picChg chg="mod">
          <ac:chgData name="Tobias Fehlmann" userId="S::tofe002@uni-saarland.de::4bcca3d1-de19-4401-a8f9-0b35f6b35757" providerId="AD" clId="Web-{B70E7169-8A18-5A25-7A73-6EB63D010669}" dt="2020-08-04T14:40:30.225" v="50" actId="1076"/>
          <ac:picMkLst>
            <pc:docMk/>
            <pc:sldMk cId="2958003938" sldId="261"/>
            <ac:picMk id="2" creationId="{410B294D-EAE8-40EA-B585-E724AEE7F865}"/>
          </ac:picMkLst>
        </pc:picChg>
      </pc:sldChg>
      <pc:sldChg chg="addSp delSp modSp">
        <pc:chgData name="Tobias Fehlmann" userId="S::tofe002@uni-saarland.de::4bcca3d1-de19-4401-a8f9-0b35f6b35757" providerId="AD" clId="Web-{B70E7169-8A18-5A25-7A73-6EB63D010669}" dt="2020-08-04T15:09:00.839" v="98" actId="14100"/>
        <pc:sldMkLst>
          <pc:docMk/>
          <pc:sldMk cId="605267594" sldId="262"/>
        </pc:sldMkLst>
        <pc:spChg chg="add mod">
          <ac:chgData name="Tobias Fehlmann" userId="S::tofe002@uni-saarland.de::4bcca3d1-de19-4401-a8f9-0b35f6b35757" providerId="AD" clId="Web-{B70E7169-8A18-5A25-7A73-6EB63D010669}" dt="2020-08-04T14:40:39.600" v="52" actId="20577"/>
          <ac:spMkLst>
            <pc:docMk/>
            <pc:sldMk cId="605267594" sldId="262"/>
            <ac:spMk id="2" creationId="{41ACC8BD-E406-4A63-B408-31623DA6C6DD}"/>
          </ac:spMkLst>
        </pc:spChg>
        <pc:picChg chg="del mod">
          <ac:chgData name="Tobias Fehlmann" userId="S::tofe002@uni-saarland.de::4bcca3d1-de19-4401-a8f9-0b35f6b35757" providerId="AD" clId="Web-{B70E7169-8A18-5A25-7A73-6EB63D010669}" dt="2020-08-04T15:08:43.011" v="95"/>
          <ac:picMkLst>
            <pc:docMk/>
            <pc:sldMk cId="605267594" sldId="262"/>
            <ac:picMk id="3" creationId="{E6E05DF9-623A-4786-A950-D2975083C252}"/>
          </ac:picMkLst>
        </pc:picChg>
        <pc:picChg chg="add mod">
          <ac:chgData name="Tobias Fehlmann" userId="S::tofe002@uni-saarland.de::4bcca3d1-de19-4401-a8f9-0b35f6b35757" providerId="AD" clId="Web-{B70E7169-8A18-5A25-7A73-6EB63D010669}" dt="2020-08-04T15:09:00.839" v="98" actId="14100"/>
          <ac:picMkLst>
            <pc:docMk/>
            <pc:sldMk cId="605267594" sldId="262"/>
            <ac:picMk id="5" creationId="{FD1CB9FE-9D05-497C-AB38-07DB62497145}"/>
          </ac:picMkLst>
        </pc:picChg>
      </pc:sldChg>
    </pc:docChg>
  </pc:docChgLst>
  <pc:docChgLst>
    <pc:chgData name="Tobias Fehlmann" userId="S::tofe002@uni-saarland.de::4bcca3d1-de19-4401-a8f9-0b35f6b35757" providerId="AD" clId="Web-{7B87B47A-4CAD-6795-07BE-BB04FB9AB105}"/>
    <pc:docChg chg="modSld">
      <pc:chgData name="Tobias Fehlmann" userId="S::tofe002@uni-saarland.de::4bcca3d1-de19-4401-a8f9-0b35f6b35757" providerId="AD" clId="Web-{7B87B47A-4CAD-6795-07BE-BB04FB9AB105}" dt="2020-07-17T09:11:27.142" v="3" actId="14100"/>
      <pc:docMkLst>
        <pc:docMk/>
      </pc:docMkLst>
      <pc:sldChg chg="addSp delSp modSp">
        <pc:chgData name="Tobias Fehlmann" userId="S::tofe002@uni-saarland.de::4bcca3d1-de19-4401-a8f9-0b35f6b35757" providerId="AD" clId="Web-{7B87B47A-4CAD-6795-07BE-BB04FB9AB105}" dt="2020-07-17T09:11:27.142" v="3" actId="14100"/>
        <pc:sldMkLst>
          <pc:docMk/>
          <pc:sldMk cId="2958003938" sldId="261"/>
        </pc:sldMkLst>
        <pc:picChg chg="add mod">
          <ac:chgData name="Tobias Fehlmann" userId="S::tofe002@uni-saarland.de::4bcca3d1-de19-4401-a8f9-0b35f6b35757" providerId="AD" clId="Web-{7B87B47A-4CAD-6795-07BE-BB04FB9AB105}" dt="2020-07-17T09:11:27.142" v="3" actId="14100"/>
          <ac:picMkLst>
            <pc:docMk/>
            <pc:sldMk cId="2958003938" sldId="261"/>
            <ac:picMk id="2" creationId="{410B294D-EAE8-40EA-B585-E724AEE7F865}"/>
          </ac:picMkLst>
        </pc:picChg>
        <pc:picChg chg="del">
          <ac:chgData name="Tobias Fehlmann" userId="S::tofe002@uni-saarland.de::4bcca3d1-de19-4401-a8f9-0b35f6b35757" providerId="AD" clId="Web-{7B87B47A-4CAD-6795-07BE-BB04FB9AB105}" dt="2020-07-17T09:11:00.188" v="0"/>
          <ac:picMkLst>
            <pc:docMk/>
            <pc:sldMk cId="2958003938" sldId="261"/>
            <ac:picMk id="4" creationId="{62F82D40-75CE-4D9D-9D10-4708CAA5093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3166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9206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9958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3200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5585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2901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4084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0206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7692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388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9888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B3054-B75A-4BD7-8B3E-8DC0F614FAF3}" type="datetimeFigureOut">
              <a:rPr lang="de-DE" smtClean="0"/>
              <a:t>05.10.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006FE-6571-4354-8775-F8708372C2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4725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sv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svg"/><Relationship Id="rId7" Type="http://schemas.openxmlformats.org/officeDocument/2006/relationships/image" Target="../media/image12.sv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sv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sv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svg"/><Relationship Id="rId7" Type="http://schemas.openxmlformats.org/officeDocument/2006/relationships/image" Target="../media/image20.sv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11" Type="http://schemas.openxmlformats.org/officeDocument/2006/relationships/image" Target="../media/image24.svg"/><Relationship Id="rId5" Type="http://schemas.openxmlformats.org/officeDocument/2006/relationships/image" Target="../media/image18.sv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1ACC8BD-E406-4A63-B408-31623DA6C6DD}"/>
              </a:ext>
            </a:extLst>
          </p:cNvPr>
          <p:cNvSpPr txBox="1"/>
          <p:nvPr/>
        </p:nvSpPr>
        <p:spPr>
          <a:xfrm>
            <a:off x="-72995" y="-46099"/>
            <a:ext cx="2743200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b="1" dirty="0">
                <a:latin typeface="Arial"/>
                <a:cs typeface="Arial"/>
              </a:rPr>
              <a:t>Supp. Figure 1</a:t>
            </a:r>
          </a:p>
        </p:txBody>
      </p:sp>
      <p:pic>
        <p:nvPicPr>
          <p:cNvPr id="5" name="Grafik 5">
            <a:extLst>
              <a:ext uri="{FF2B5EF4-FFF2-40B4-BE49-F238E27FC236}">
                <a16:creationId xmlns:a16="http://schemas.microsoft.com/office/drawing/2014/main" id="{FD1CB9FE-9D05-497C-AB38-07DB624971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395" y="341023"/>
            <a:ext cx="6842722" cy="9427676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0E508A04-B87D-0048-B953-890088978F50}"/>
              </a:ext>
            </a:extLst>
          </p:cNvPr>
          <p:cNvSpPr txBox="1"/>
          <p:nvPr/>
        </p:nvSpPr>
        <p:spPr>
          <a:xfrm>
            <a:off x="3395" y="4005942"/>
            <a:ext cx="23596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600" dirty="0"/>
              <a:t>I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B8D6685-B832-154A-B401-CDCD627DFF24}"/>
              </a:ext>
            </a:extLst>
          </p:cNvPr>
          <p:cNvSpPr txBox="1"/>
          <p:nvPr/>
        </p:nvSpPr>
        <p:spPr>
          <a:xfrm>
            <a:off x="3308270" y="4005942"/>
            <a:ext cx="250390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600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605267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3">
            <a:extLst>
              <a:ext uri="{FF2B5EF4-FFF2-40B4-BE49-F238E27FC236}">
                <a16:creationId xmlns:a16="http://schemas.microsoft.com/office/drawing/2014/main" id="{BAF90315-7961-43ED-AD70-A4A7C6456D3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395" y="506599"/>
            <a:ext cx="6851208" cy="3247994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7A71BACE-4A49-4BCE-8223-A7A7A8C2347B}"/>
              </a:ext>
            </a:extLst>
          </p:cNvPr>
          <p:cNvSpPr txBox="1"/>
          <p:nvPr/>
        </p:nvSpPr>
        <p:spPr>
          <a:xfrm>
            <a:off x="-72995" y="-46099"/>
            <a:ext cx="2743200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b="1" dirty="0">
                <a:latin typeface="Arial"/>
                <a:cs typeface="Arial"/>
              </a:rPr>
              <a:t>Supp. Figure 2</a:t>
            </a:r>
          </a:p>
        </p:txBody>
      </p:sp>
    </p:spTree>
    <p:extLst>
      <p:ext uri="{BB962C8B-B14F-4D97-AF65-F5344CB8AC3E}">
        <p14:creationId xmlns:p14="http://schemas.microsoft.com/office/powerpoint/2010/main" val="522985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2">
            <a:extLst>
              <a:ext uri="{FF2B5EF4-FFF2-40B4-BE49-F238E27FC236}">
                <a16:creationId xmlns:a16="http://schemas.microsoft.com/office/drawing/2014/main" id="{410B294D-EAE8-40EA-B585-E724AEE7F8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6254" y="386776"/>
            <a:ext cx="6845059" cy="3256893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1632CA7C-2411-4FB1-876D-EA9693C76C2C}"/>
              </a:ext>
            </a:extLst>
          </p:cNvPr>
          <p:cNvSpPr txBox="1"/>
          <p:nvPr/>
        </p:nvSpPr>
        <p:spPr>
          <a:xfrm>
            <a:off x="-72995" y="-46099"/>
            <a:ext cx="2743200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b="1" dirty="0">
                <a:latin typeface="Arial"/>
                <a:cs typeface="Arial"/>
              </a:rPr>
              <a:t>Supp. Figure 3</a:t>
            </a:r>
          </a:p>
        </p:txBody>
      </p:sp>
    </p:spTree>
    <p:extLst>
      <p:ext uri="{BB962C8B-B14F-4D97-AF65-F5344CB8AC3E}">
        <p14:creationId xmlns:p14="http://schemas.microsoft.com/office/powerpoint/2010/main" val="29580039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4">
            <a:extLst>
              <a:ext uri="{FF2B5EF4-FFF2-40B4-BE49-F238E27FC236}">
                <a16:creationId xmlns:a16="http://schemas.microsoft.com/office/drawing/2014/main" id="{59A8BAEB-519D-4497-8DCC-2C7E41564B2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-6789" y="269065"/>
            <a:ext cx="6817256" cy="1965830"/>
          </a:xfrm>
          <a:prstGeom prst="rect">
            <a:avLst/>
          </a:prstGeom>
        </p:spPr>
      </p:pic>
      <p:pic>
        <p:nvPicPr>
          <p:cNvPr id="5" name="Grafik 5">
            <a:extLst>
              <a:ext uri="{FF2B5EF4-FFF2-40B4-BE49-F238E27FC236}">
                <a16:creationId xmlns:a16="http://schemas.microsoft.com/office/drawing/2014/main" id="{1E7E6C0D-CCEE-4349-9029-22CBE708D2E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1111" y="2187892"/>
            <a:ext cx="6613555" cy="2321263"/>
          </a:xfrm>
          <a:prstGeom prst="rect">
            <a:avLst/>
          </a:prstGeom>
        </p:spPr>
      </p:pic>
      <p:pic>
        <p:nvPicPr>
          <p:cNvPr id="6" name="Grafik 6">
            <a:extLst>
              <a:ext uri="{FF2B5EF4-FFF2-40B4-BE49-F238E27FC236}">
                <a16:creationId xmlns:a16="http://schemas.microsoft.com/office/drawing/2014/main" id="{BBFE84DC-F5B7-49C7-AA54-9B169827F51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74691" y="4799920"/>
            <a:ext cx="3625912" cy="3149366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19AF46BC-24B5-4027-BEAF-9F6C3B196349}"/>
              </a:ext>
            </a:extLst>
          </p:cNvPr>
          <p:cNvSpPr txBox="1"/>
          <p:nvPr/>
        </p:nvSpPr>
        <p:spPr>
          <a:xfrm>
            <a:off x="6790" y="4571899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>
                <a:latin typeface="Arial"/>
                <a:cs typeface="Arial"/>
              </a:rPr>
              <a:t>G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1433B60D-C21E-4738-A749-A270B53DE167}"/>
              </a:ext>
            </a:extLst>
          </p:cNvPr>
          <p:cNvSpPr txBox="1"/>
          <p:nvPr/>
        </p:nvSpPr>
        <p:spPr>
          <a:xfrm>
            <a:off x="-72995" y="-46099"/>
            <a:ext cx="2743200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b="1" dirty="0">
                <a:latin typeface="Arial"/>
                <a:cs typeface="Arial"/>
              </a:rPr>
              <a:t>Supp. Figure 4</a:t>
            </a:r>
          </a:p>
        </p:txBody>
      </p:sp>
    </p:spTree>
    <p:extLst>
      <p:ext uri="{BB962C8B-B14F-4D97-AF65-F5344CB8AC3E}">
        <p14:creationId xmlns:p14="http://schemas.microsoft.com/office/powerpoint/2010/main" val="15774998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2">
            <a:extLst>
              <a:ext uri="{FF2B5EF4-FFF2-40B4-BE49-F238E27FC236}">
                <a16:creationId xmlns:a16="http://schemas.microsoft.com/office/drawing/2014/main" id="{9992E18E-0A0A-487E-96A4-F8766E1944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45833" y="305294"/>
            <a:ext cx="6766333" cy="4830494"/>
          </a:xfrm>
          <a:prstGeom prst="rect">
            <a:avLst/>
          </a:prstGeom>
        </p:spPr>
      </p:pic>
      <p:sp>
        <p:nvSpPr>
          <p:cNvPr id="5" name="Textfeld 1">
            <a:extLst>
              <a:ext uri="{FF2B5EF4-FFF2-40B4-BE49-F238E27FC236}">
                <a16:creationId xmlns:a16="http://schemas.microsoft.com/office/drawing/2014/main" id="{13390F6F-6E6D-4971-BD39-7BA53E2CC75F}"/>
              </a:ext>
            </a:extLst>
          </p:cNvPr>
          <p:cNvSpPr txBox="1"/>
          <p:nvPr/>
        </p:nvSpPr>
        <p:spPr>
          <a:xfrm>
            <a:off x="-72995" y="-46099"/>
            <a:ext cx="2743200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b="1" dirty="0">
                <a:latin typeface="Arial"/>
                <a:cs typeface="Arial"/>
              </a:rPr>
              <a:t>Supp. Figure 5</a:t>
            </a:r>
          </a:p>
        </p:txBody>
      </p:sp>
    </p:spTree>
    <p:extLst>
      <p:ext uri="{BB962C8B-B14F-4D97-AF65-F5344CB8AC3E}">
        <p14:creationId xmlns:p14="http://schemas.microsoft.com/office/powerpoint/2010/main" val="15789345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4">
            <a:extLst>
              <a:ext uri="{FF2B5EF4-FFF2-40B4-BE49-F238E27FC236}">
                <a16:creationId xmlns:a16="http://schemas.microsoft.com/office/drawing/2014/main" id="{00ECBD10-DAD4-4EFA-84F4-F7668BE83D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5064" y="361524"/>
            <a:ext cx="6697812" cy="3167772"/>
          </a:xfrm>
          <a:prstGeom prst="rect">
            <a:avLst/>
          </a:prstGeom>
        </p:spPr>
      </p:pic>
      <p:pic>
        <p:nvPicPr>
          <p:cNvPr id="5" name="Grafik 5">
            <a:extLst>
              <a:ext uri="{FF2B5EF4-FFF2-40B4-BE49-F238E27FC236}">
                <a16:creationId xmlns:a16="http://schemas.microsoft.com/office/drawing/2014/main" id="{CE968539-854D-436D-8752-F690C8FC8B5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5006" y="4063863"/>
            <a:ext cx="3081093" cy="2016880"/>
          </a:xfrm>
          <a:prstGeom prst="rect">
            <a:avLst/>
          </a:prstGeom>
        </p:spPr>
      </p:pic>
      <p:pic>
        <p:nvPicPr>
          <p:cNvPr id="6" name="Grafik 6">
            <a:extLst>
              <a:ext uri="{FF2B5EF4-FFF2-40B4-BE49-F238E27FC236}">
                <a16:creationId xmlns:a16="http://schemas.microsoft.com/office/drawing/2014/main" id="{06991170-43EC-4D06-9711-BE764CE94A7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55065" y="6758274"/>
            <a:ext cx="3819454" cy="1906257"/>
          </a:xfrm>
          <a:prstGeom prst="rect">
            <a:avLst/>
          </a:prstGeom>
        </p:spPr>
      </p:pic>
      <p:pic>
        <p:nvPicPr>
          <p:cNvPr id="7" name="Grafik 7">
            <a:extLst>
              <a:ext uri="{FF2B5EF4-FFF2-40B4-BE49-F238E27FC236}">
                <a16:creationId xmlns:a16="http://schemas.microsoft.com/office/drawing/2014/main" id="{CE1E6D7D-4150-4D30-99C1-4051E97D2D0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3133653" y="4059528"/>
            <a:ext cx="3619222" cy="2025550"/>
          </a:xfrm>
          <a:prstGeom prst="rect">
            <a:avLst/>
          </a:prstGeom>
        </p:spPr>
      </p:pic>
      <p:pic>
        <p:nvPicPr>
          <p:cNvPr id="8" name="Grafik 8">
            <a:extLst>
              <a:ext uri="{FF2B5EF4-FFF2-40B4-BE49-F238E27FC236}">
                <a16:creationId xmlns:a16="http://schemas.microsoft.com/office/drawing/2014/main" id="{8629DAD4-AF49-4DB7-8200-55BA426FACD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3258802" y="6760164"/>
            <a:ext cx="3581677" cy="1939999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BBD786A5-571F-400C-BCCF-4F8B6EC749B0}"/>
              </a:ext>
            </a:extLst>
          </p:cNvPr>
          <p:cNvSpPr txBox="1"/>
          <p:nvPr/>
        </p:nvSpPr>
        <p:spPr>
          <a:xfrm>
            <a:off x="1265851" y="3611708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 err="1">
                <a:latin typeface="Arial"/>
                <a:cs typeface="Arial"/>
              </a:rPr>
              <a:t>Illumina</a:t>
            </a:r>
            <a:endParaRPr lang="de-DE" sz="1400" b="1">
              <a:latin typeface="Arial"/>
              <a:cs typeface="Arial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EEF2B6C-BA4A-4662-9419-577933A90AC2}"/>
              </a:ext>
            </a:extLst>
          </p:cNvPr>
          <p:cNvSpPr txBox="1"/>
          <p:nvPr/>
        </p:nvSpPr>
        <p:spPr>
          <a:xfrm>
            <a:off x="1265851" y="6418697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 err="1">
                <a:latin typeface="Arial"/>
                <a:cs typeface="Arial"/>
              </a:rPr>
              <a:t>Illumina</a:t>
            </a:r>
            <a:endParaRPr lang="de-DE" sz="1400" b="1">
              <a:latin typeface="Arial"/>
              <a:cs typeface="Arial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776C0142-85D0-4E7F-BA5B-98553BFD9FE2}"/>
              </a:ext>
            </a:extLst>
          </p:cNvPr>
          <p:cNvSpPr txBox="1"/>
          <p:nvPr/>
        </p:nvSpPr>
        <p:spPr>
          <a:xfrm>
            <a:off x="4583263" y="3609783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 err="1">
                <a:latin typeface="Arial"/>
                <a:cs typeface="Arial"/>
              </a:rPr>
              <a:t>CoolMPS</a:t>
            </a:r>
            <a:endParaRPr lang="de-DE" sz="1600" b="1">
              <a:latin typeface="Arial"/>
              <a:cs typeface="Arial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42734F2-8ED6-4D2C-BAA8-E44FD57CDF5D}"/>
              </a:ext>
            </a:extLst>
          </p:cNvPr>
          <p:cNvSpPr txBox="1"/>
          <p:nvPr/>
        </p:nvSpPr>
        <p:spPr>
          <a:xfrm>
            <a:off x="4588476" y="6441787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 err="1">
                <a:latin typeface="Arial"/>
                <a:cs typeface="Arial"/>
              </a:rPr>
              <a:t>CoolMPS</a:t>
            </a:r>
            <a:endParaRPr lang="de-DE" sz="1400" b="1" dirty="0">
              <a:latin typeface="Arial"/>
              <a:cs typeface="Arial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FE86D2E-B703-4D32-8048-7B9F53D4A17C}"/>
              </a:ext>
            </a:extLst>
          </p:cNvPr>
          <p:cNvSpPr txBox="1"/>
          <p:nvPr/>
        </p:nvSpPr>
        <p:spPr>
          <a:xfrm>
            <a:off x="833" y="268336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CF8BB873-5E9B-4B8D-B9ED-2062C76DA252}"/>
              </a:ext>
            </a:extLst>
          </p:cNvPr>
          <p:cNvSpPr txBox="1"/>
          <p:nvPr/>
        </p:nvSpPr>
        <p:spPr>
          <a:xfrm>
            <a:off x="6048" y="3613151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2D68AF1-F188-45E1-8EAA-11E35B676537}"/>
              </a:ext>
            </a:extLst>
          </p:cNvPr>
          <p:cNvSpPr txBox="1"/>
          <p:nvPr/>
        </p:nvSpPr>
        <p:spPr>
          <a:xfrm>
            <a:off x="3002252" y="3618443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>
                <a:latin typeface="Arial"/>
                <a:cs typeface="Arial"/>
              </a:rPr>
              <a:t>C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BC49AB90-1E01-4192-8C7D-A7EB7707E3C3}"/>
              </a:ext>
            </a:extLst>
          </p:cNvPr>
          <p:cNvSpPr txBox="1"/>
          <p:nvPr/>
        </p:nvSpPr>
        <p:spPr>
          <a:xfrm>
            <a:off x="-8552" y="6437939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>
                <a:latin typeface="Arial"/>
                <a:cs typeface="Arial"/>
              </a:rPr>
              <a:t>D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51E543CC-083E-4E07-BDC5-E2E3992E0490}"/>
              </a:ext>
            </a:extLst>
          </p:cNvPr>
          <p:cNvSpPr txBox="1"/>
          <p:nvPr/>
        </p:nvSpPr>
        <p:spPr>
          <a:xfrm>
            <a:off x="3100283" y="6443230"/>
            <a:ext cx="2743200" cy="30777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de-DE" sz="1400" b="1" dirty="0">
                <a:latin typeface="Arial"/>
                <a:cs typeface="Arial"/>
              </a:rPr>
              <a:t>E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62623E29-8183-4EB1-AB43-B92DB89C3EC6}"/>
              </a:ext>
            </a:extLst>
          </p:cNvPr>
          <p:cNvSpPr txBox="1"/>
          <p:nvPr/>
        </p:nvSpPr>
        <p:spPr>
          <a:xfrm>
            <a:off x="-72995" y="-46099"/>
            <a:ext cx="2743200" cy="338554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sz="1600" b="1" dirty="0">
                <a:latin typeface="Arial"/>
                <a:cs typeface="Arial"/>
              </a:rPr>
              <a:t>Supp. Figure 6</a:t>
            </a:r>
          </a:p>
        </p:txBody>
      </p:sp>
    </p:spTree>
    <p:extLst>
      <p:ext uri="{BB962C8B-B14F-4D97-AF65-F5344CB8AC3E}">
        <p14:creationId xmlns:p14="http://schemas.microsoft.com/office/powerpoint/2010/main" val="323631143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Macintosh PowerPoint</Application>
  <PresentationFormat>A4-Papier (210 x 297 mm)</PresentationFormat>
  <Paragraphs>18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/>
  <cp:lastModifiedBy>Andreas Keller</cp:lastModifiedBy>
  <cp:revision>250</cp:revision>
  <dcterms:created xsi:type="dcterms:W3CDTF">2020-07-10T15:50:36Z</dcterms:created>
  <dcterms:modified xsi:type="dcterms:W3CDTF">2020-10-05T13:38:40Z</dcterms:modified>
</cp:coreProperties>
</file>